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257" r:id="rId2"/>
    <p:sldId id="267" r:id="rId3"/>
    <p:sldId id="261" r:id="rId4"/>
    <p:sldId id="277" r:id="rId5"/>
    <p:sldId id="265" r:id="rId6"/>
    <p:sldId id="274" r:id="rId7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7F7F"/>
    <a:srgbClr val="E0E0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829" autoAdjust="0"/>
    <p:restoredTop sz="93069" autoAdjust="0"/>
  </p:normalViewPr>
  <p:slideViewPr>
    <p:cSldViewPr snapToGrid="0">
      <p:cViewPr>
        <p:scale>
          <a:sx n="150" d="100"/>
          <a:sy n="150" d="100"/>
        </p:scale>
        <p:origin x="3342" y="-20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5466" cy="502951"/>
          </a:xfrm>
          <a:prstGeom prst="rect">
            <a:avLst/>
          </a:prstGeom>
        </p:spPr>
        <p:txBody>
          <a:bodyPr vert="horz" lIns="93113" tIns="46557" rIns="93113" bIns="4655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074" y="0"/>
            <a:ext cx="2985465" cy="502951"/>
          </a:xfrm>
          <a:prstGeom prst="rect">
            <a:avLst/>
          </a:prstGeom>
        </p:spPr>
        <p:txBody>
          <a:bodyPr vert="horz" lIns="93113" tIns="46557" rIns="93113" bIns="46557" rtlCol="0"/>
          <a:lstStyle>
            <a:lvl1pPr algn="r">
              <a:defRPr sz="1200"/>
            </a:lvl1pPr>
          </a:lstStyle>
          <a:p>
            <a:fld id="{88216C9F-C612-457C-A307-55FFD9B9CB0F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252538"/>
            <a:ext cx="2338387" cy="33797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13" tIns="46557" rIns="93113" bIns="46557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330" y="4821556"/>
            <a:ext cx="5511505" cy="3944616"/>
          </a:xfrm>
          <a:prstGeom prst="rect">
            <a:avLst/>
          </a:prstGeom>
        </p:spPr>
        <p:txBody>
          <a:bodyPr vert="horz" lIns="93113" tIns="46557" rIns="93113" bIns="46557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515762"/>
            <a:ext cx="2985466" cy="502951"/>
          </a:xfrm>
          <a:prstGeom prst="rect">
            <a:avLst/>
          </a:prstGeom>
        </p:spPr>
        <p:txBody>
          <a:bodyPr vert="horz" lIns="93113" tIns="46557" rIns="93113" bIns="4655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074" y="9515762"/>
            <a:ext cx="2985465" cy="502951"/>
          </a:xfrm>
          <a:prstGeom prst="rect">
            <a:avLst/>
          </a:prstGeom>
        </p:spPr>
        <p:txBody>
          <a:bodyPr vert="horz" lIns="93113" tIns="46557" rIns="93113" bIns="46557" rtlCol="0" anchor="b"/>
          <a:lstStyle>
            <a:lvl1pPr algn="r">
              <a:defRPr sz="1200"/>
            </a:lvl1pPr>
          </a:lstStyle>
          <a:p>
            <a:fld id="{9E127B70-0AF0-4525-8746-6933C0150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2324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28549" rtl="0" eaLnBrk="1" latinLnBrk="0" hangingPunct="1">
      <a:defRPr kumimoji="1" sz="824" kern="1200">
        <a:solidFill>
          <a:schemeClr val="tx1"/>
        </a:solidFill>
        <a:latin typeface="+mn-lt"/>
        <a:ea typeface="+mn-ea"/>
        <a:cs typeface="+mn-cs"/>
      </a:defRPr>
    </a:lvl1pPr>
    <a:lvl2pPr marL="314274" algn="l" defTabSz="628549" rtl="0" eaLnBrk="1" latinLnBrk="0" hangingPunct="1">
      <a:defRPr kumimoji="1" sz="824" kern="1200">
        <a:solidFill>
          <a:schemeClr val="tx1"/>
        </a:solidFill>
        <a:latin typeface="+mn-lt"/>
        <a:ea typeface="+mn-ea"/>
        <a:cs typeface="+mn-cs"/>
      </a:defRPr>
    </a:lvl2pPr>
    <a:lvl3pPr marL="628549" algn="l" defTabSz="628549" rtl="0" eaLnBrk="1" latinLnBrk="0" hangingPunct="1">
      <a:defRPr kumimoji="1" sz="824" kern="1200">
        <a:solidFill>
          <a:schemeClr val="tx1"/>
        </a:solidFill>
        <a:latin typeface="+mn-lt"/>
        <a:ea typeface="+mn-ea"/>
        <a:cs typeface="+mn-cs"/>
      </a:defRPr>
    </a:lvl3pPr>
    <a:lvl4pPr marL="942823" algn="l" defTabSz="628549" rtl="0" eaLnBrk="1" latinLnBrk="0" hangingPunct="1">
      <a:defRPr kumimoji="1" sz="824" kern="1200">
        <a:solidFill>
          <a:schemeClr val="tx1"/>
        </a:solidFill>
        <a:latin typeface="+mn-lt"/>
        <a:ea typeface="+mn-ea"/>
        <a:cs typeface="+mn-cs"/>
      </a:defRPr>
    </a:lvl4pPr>
    <a:lvl5pPr marL="1257099" algn="l" defTabSz="628549" rtl="0" eaLnBrk="1" latinLnBrk="0" hangingPunct="1">
      <a:defRPr kumimoji="1" sz="824" kern="1200">
        <a:solidFill>
          <a:schemeClr val="tx1"/>
        </a:solidFill>
        <a:latin typeface="+mn-lt"/>
        <a:ea typeface="+mn-ea"/>
        <a:cs typeface="+mn-cs"/>
      </a:defRPr>
    </a:lvl5pPr>
    <a:lvl6pPr marL="1571373" algn="l" defTabSz="628549" rtl="0" eaLnBrk="1" latinLnBrk="0" hangingPunct="1">
      <a:defRPr kumimoji="1" sz="824" kern="1200">
        <a:solidFill>
          <a:schemeClr val="tx1"/>
        </a:solidFill>
        <a:latin typeface="+mn-lt"/>
        <a:ea typeface="+mn-ea"/>
        <a:cs typeface="+mn-cs"/>
      </a:defRPr>
    </a:lvl6pPr>
    <a:lvl7pPr marL="1885647" algn="l" defTabSz="628549" rtl="0" eaLnBrk="1" latinLnBrk="0" hangingPunct="1">
      <a:defRPr kumimoji="1" sz="824" kern="1200">
        <a:solidFill>
          <a:schemeClr val="tx1"/>
        </a:solidFill>
        <a:latin typeface="+mn-lt"/>
        <a:ea typeface="+mn-ea"/>
        <a:cs typeface="+mn-cs"/>
      </a:defRPr>
    </a:lvl7pPr>
    <a:lvl8pPr marL="2199922" algn="l" defTabSz="628549" rtl="0" eaLnBrk="1" latinLnBrk="0" hangingPunct="1">
      <a:defRPr kumimoji="1" sz="824" kern="1200">
        <a:solidFill>
          <a:schemeClr val="tx1"/>
        </a:solidFill>
        <a:latin typeface="+mn-lt"/>
        <a:ea typeface="+mn-ea"/>
        <a:cs typeface="+mn-cs"/>
      </a:defRPr>
    </a:lvl8pPr>
    <a:lvl9pPr marL="2514196" algn="l" defTabSz="628549" rtl="0" eaLnBrk="1" latinLnBrk="0" hangingPunct="1">
      <a:defRPr kumimoji="1" sz="82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252538"/>
            <a:ext cx="2338387" cy="33797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127B70-0AF0-4525-8746-6933C0150B2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68907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252538"/>
            <a:ext cx="2338387" cy="33797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127B70-0AF0-4525-8746-6933C0150B2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02355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252538"/>
            <a:ext cx="2338387" cy="33797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127B70-0AF0-4525-8746-6933C0150B2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9670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127B70-0AF0-4525-8746-6933C0150B2E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68405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252538"/>
            <a:ext cx="2338387" cy="33797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127B70-0AF0-4525-8746-6933C0150B2E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024682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252538"/>
            <a:ext cx="2338387" cy="33797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127B70-0AF0-4525-8746-6933C0150B2E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536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808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0519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688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1756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4588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302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2669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096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4588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368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007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4EBE8-3BDE-47E6-8E71-919C6D652443}" type="datetimeFigureOut">
              <a:rPr kumimoji="1" lang="ja-JP" altLang="en-US" smtClean="0"/>
              <a:t>2025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964EE-181E-40B3-AB65-8CB221CDED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4332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FE68B25-7309-47B9-505C-B66958FAEE0D}"/>
              </a:ext>
            </a:extLst>
          </p:cNvPr>
          <p:cNvSpPr txBox="1"/>
          <p:nvPr/>
        </p:nvSpPr>
        <p:spPr>
          <a:xfrm>
            <a:off x="2288649" y="1942158"/>
            <a:ext cx="2280702" cy="1962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75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plemental Data S1. Patient characteristics</a:t>
            </a:r>
            <a:endParaRPr lang="ja-JP" altLang="en-US" sz="67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C058798C-F589-0F8A-2E5F-18B3B5B64A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878959"/>
              </p:ext>
            </p:extLst>
          </p:nvPr>
        </p:nvGraphicFramePr>
        <p:xfrm>
          <a:off x="2184353" y="2248235"/>
          <a:ext cx="2496259" cy="5048700"/>
        </p:xfrm>
        <a:graphic>
          <a:graphicData uri="http://schemas.openxmlformats.org/drawingml/2006/table">
            <a:tbl>
              <a:tblPr/>
              <a:tblGrid>
                <a:gridCol w="1437338">
                  <a:extLst>
                    <a:ext uri="{9D8B030D-6E8A-4147-A177-3AD203B41FA5}">
                      <a16:colId xmlns:a16="http://schemas.microsoft.com/office/drawing/2014/main" val="2893404321"/>
                    </a:ext>
                  </a:extLst>
                </a:gridCol>
                <a:gridCol w="1058921">
                  <a:extLst>
                    <a:ext uri="{9D8B030D-6E8A-4147-A177-3AD203B41FA5}">
                      <a16:colId xmlns:a16="http://schemas.microsoft.com/office/drawing/2014/main" val="3686507376"/>
                    </a:ext>
                  </a:extLst>
                </a:gridCol>
              </a:tblGrid>
              <a:tr h="206325"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Characteristics</a:t>
                      </a:r>
                    </a:p>
                  </a:txBody>
                  <a:tcPr marL="11609" marR="11609" marT="11609" marB="11609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7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patients (</a:t>
                      </a:r>
                      <a:r>
                        <a:rPr lang="en-US" sz="700" b="1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7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 79)</a:t>
                      </a:r>
                    </a:p>
                  </a:txBody>
                  <a:tcPr marL="11609" marR="11609" marT="11609" marB="11609" anchor="ctr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792956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algn="l" fontAlgn="t"/>
                      <a:endParaRPr lang="en-US" sz="7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7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2761622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Age, </a:t>
                      </a:r>
                      <a:r>
                        <a:rPr lang="en-US" sz="700" i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range)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(40–88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484897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Male/female, </a:t>
                      </a:r>
                      <a:r>
                        <a:rPr lang="en-US" sz="70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 </a:t>
                      </a:r>
                      <a:r>
                        <a:rPr lang="en-US" altLang="ja-JP" sz="7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74.7</a:t>
                      </a: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/20 </a:t>
                      </a:r>
                      <a:r>
                        <a:rPr lang="en-US" altLang="ja-JP" sz="7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5.3</a:t>
                      </a: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4032948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Most recent cancer stage, </a:t>
                      </a:r>
                      <a:r>
                        <a:rPr lang="en-US" sz="70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8901526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I </a:t>
                      </a:r>
                      <a:r>
                        <a:rPr lang="en-US" altLang="ja-JP" sz="700" kern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</a:t>
                      </a:r>
                      <a:endParaRPr 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6.3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6194465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ja-JP" alt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</a:t>
                      </a: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 </a:t>
                      </a:r>
                      <a:r>
                        <a:rPr lang="en-US" altLang="ja-JP" sz="700" kern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</a:t>
                      </a:r>
                      <a:endParaRPr 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7.6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5278107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IIIA </a:t>
                      </a:r>
                      <a:r>
                        <a:rPr lang="en-US" altLang="ja-JP" sz="700" kern="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</a:t>
                      </a:r>
                      <a:r>
                        <a:rPr lang="en-US" altLang="ja-JP" sz="700" kern="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 </a:t>
                      </a:r>
                      <a:endParaRPr 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8.9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4065292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IIIB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10.1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5139484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</a:t>
                      </a: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C</a:t>
                      </a:r>
                      <a:endParaRPr 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.3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0610718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IVA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32.9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3322201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</a:t>
                      </a: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B</a:t>
                      </a:r>
                      <a:endParaRPr 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32.9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0009847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algn="l"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Histology at diagnosis, </a:t>
                      </a:r>
                      <a:r>
                        <a:rPr lang="en-US" sz="70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1977033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Adenocarcinoma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 (65.8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9993567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Squamous cell carcinoma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20.3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1268043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Pleomorphic carcinoma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.5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8229317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Large cell carcinoma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.3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0794349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Non-small cell lung carcinoma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5.1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4005979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Not specified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5.1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3106049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PD-L1 status, </a:t>
                      </a:r>
                      <a:r>
                        <a:rPr lang="en-US" sz="70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1928104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TPS &lt; 1 %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(35.4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671883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TPS 1–49 %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20.3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3258334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TPS</a:t>
                      </a: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≥ </a:t>
                      </a:r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%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 (40.5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2312674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Unknown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3.8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1431963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Line of therapy, </a:t>
                      </a:r>
                      <a:r>
                        <a:rPr lang="en-US" sz="70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7644955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1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 (69.6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4680810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2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16.5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6214717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≥3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13.9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3829941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Regimen, </a:t>
                      </a:r>
                      <a:r>
                        <a:rPr lang="en-US" sz="70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6508448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</a:t>
                      </a:r>
                      <a:r>
                        <a:rPr lang="en-US" sz="7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I+Chemotherapy</a:t>
                      </a:r>
                      <a:endParaRPr 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 (39.2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2005324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ICI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 (27.8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0917942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Chemotherapy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32.9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2109052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Driver mutation, </a:t>
                      </a:r>
                      <a:r>
                        <a:rPr lang="en-US" altLang="ja-JP" sz="700" i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US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altLang="ja-JP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703295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EGFR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10.1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4731383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ALK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(0.0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1354169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ROS-1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.3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3221718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BRAF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.5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6086473"/>
                  </a:ext>
                </a:extLst>
              </a:tr>
              <a:tr h="130875">
                <a:tc>
                  <a:txBody>
                    <a:bodyPr/>
                    <a:lstStyle/>
                    <a:p>
                      <a:pPr fontAlgn="t"/>
                      <a:r>
                        <a:rPr lang="en-US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Negative/Unknown</a:t>
                      </a:r>
                    </a:p>
                  </a:txBody>
                  <a:tcPr marL="11609" marR="11609" marT="11609" marB="11609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 (86.1)</a:t>
                      </a:r>
                    </a:p>
                  </a:txBody>
                  <a:tcPr marL="11609" marR="11609" marT="11609" marB="11609">
                    <a:lnL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DCDCD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4433911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D4D34D3-09F2-8DAC-2354-F081C6E36639}"/>
              </a:ext>
            </a:extLst>
          </p:cNvPr>
          <p:cNvSpPr txBox="1"/>
          <p:nvPr/>
        </p:nvSpPr>
        <p:spPr>
          <a:xfrm>
            <a:off x="2184103" y="7392532"/>
            <a:ext cx="2567776" cy="6117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675" dirty="0">
                <a:latin typeface="Arial" panose="020B0604020202020204" pitchFamily="34" charset="0"/>
                <a:cs typeface="Arial" panose="020B0604020202020204" pitchFamily="34" charset="0"/>
              </a:rPr>
              <a:t>Abbreviations: PD-L1, programmed cell death/programmed cell death ligand-1; TPS, tumor proportion score; ICI, immune checkpoint inhibitor; EGFR, epidermal growth factor receptor; ALK, anaplastic lymphoma kinase.</a:t>
            </a:r>
          </a:p>
          <a:p>
            <a:r>
              <a:rPr lang="en-US" altLang="ja-JP" sz="675" kern="0" baseline="30000" dirty="0">
                <a:latin typeface="Arial" panose="020B0604020202020204" pitchFamily="34" charset="0"/>
                <a:ea typeface="ＭＳ Ｐゴシック" panose="020B0600070205080204" pitchFamily="50" charset="-128"/>
              </a:rPr>
              <a:t>a </a:t>
            </a:r>
            <a:r>
              <a:rPr lang="en-US" altLang="ja-JP" sz="675" dirty="0">
                <a:latin typeface="Arial" panose="020B0604020202020204" pitchFamily="34" charset="0"/>
                <a:cs typeface="Arial" panose="020B0604020202020204" pitchFamily="34" charset="0"/>
              </a:rPr>
              <a:t>Patients were enrolled after post-operative recurrence.</a:t>
            </a: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D8681BB2-EA2D-8533-1F4B-53BE8D6CF1B4}"/>
              </a:ext>
            </a:extLst>
          </p:cNvPr>
          <p:cNvCxnSpPr/>
          <p:nvPr/>
        </p:nvCxnSpPr>
        <p:spPr>
          <a:xfrm>
            <a:off x="2184103" y="2449607"/>
            <a:ext cx="249625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326297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A742CEAA-B017-73AE-0498-2A3F708DF0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2186400"/>
              </p:ext>
            </p:extLst>
          </p:nvPr>
        </p:nvGraphicFramePr>
        <p:xfrm>
          <a:off x="3377785" y="2983228"/>
          <a:ext cx="2306680" cy="25721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061514" imgH="3416781" progId="Prism8.Document">
                  <p:embed/>
                </p:oleObj>
              </mc:Choice>
              <mc:Fallback>
                <p:oleObj name="Prism 8" r:id="rId3" imgW="3061514" imgH="3416781" progId="Prism8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A742CEAA-B017-73AE-0498-2A3F708DF0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77785" y="2983228"/>
                        <a:ext cx="2306680" cy="25721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4BB60E9-57AA-0B34-E352-FF2823CE3DBD}"/>
              </a:ext>
            </a:extLst>
          </p:cNvPr>
          <p:cNvSpPr txBox="1"/>
          <p:nvPr/>
        </p:nvSpPr>
        <p:spPr>
          <a:xfrm>
            <a:off x="2021681" y="5846597"/>
            <a:ext cx="2935778" cy="6372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506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plemental Data S2. </a:t>
            </a:r>
            <a:r>
              <a:rPr lang="en-US" altLang="ja-JP" sz="506" b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omparison of circulating tumor cells between non-small-cell lung cancer patients and control individuals</a:t>
            </a:r>
          </a:p>
          <a:p>
            <a:endParaRPr lang="en-US" altLang="ja-JP" sz="506" b="1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he total CTC counts (A) and the </a:t>
            </a:r>
            <a:r>
              <a:rPr lang="en-US" altLang="ja-JP" sz="506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rogrammed death-ligand 1 (PD-L1)</a:t>
            </a:r>
            <a:r>
              <a:rPr lang="en-US" altLang="ja-JP" sz="506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+) </a:t>
            </a:r>
            <a:r>
              <a:rPr lang="en-US" altLang="ja-JP" sz="506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TC counts (B) of patients with NSCLC were significantly higher than those of healthy individuals and patients with non-carcinomatous lung disease. </a:t>
            </a:r>
            <a:r>
              <a:rPr lang="en-US" altLang="ja-JP" sz="506" i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US" altLang="ja-JP" sz="506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-values were calculated using the Kruskal–Wallis test and post hoc analysis (Dunn–Bonferroni test).</a:t>
            </a:r>
            <a:endParaRPr lang="en-US" altLang="ja-JP" sz="50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FB4BFEC6-0600-C91F-1997-EED76B9D80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0687170"/>
              </p:ext>
            </p:extLst>
          </p:nvPr>
        </p:nvGraphicFramePr>
        <p:xfrm>
          <a:off x="1017827" y="2983228"/>
          <a:ext cx="2280993" cy="25721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3032343" imgH="3419663" progId="Prism8.Document">
                  <p:embed/>
                </p:oleObj>
              </mc:Choice>
              <mc:Fallback>
                <p:oleObj name="Prism 8" r:id="rId5" imgW="3032343" imgH="3419663" progId="Prism8.Document">
                  <p:embed/>
                  <p:pic>
                    <p:nvPicPr>
                      <p:cNvPr id="10" name="オブジェクト 9">
                        <a:extLst>
                          <a:ext uri="{FF2B5EF4-FFF2-40B4-BE49-F238E27FC236}">
                            <a16:creationId xmlns:a16="http://schemas.microsoft.com/office/drawing/2014/main" id="{6381ADF0-8872-5128-6DAB-F0022CE127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17827" y="2983228"/>
                        <a:ext cx="2280993" cy="25721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96051C7-5080-DAC9-7833-7F8F8877D3E0}"/>
              </a:ext>
            </a:extLst>
          </p:cNvPr>
          <p:cNvSpPr txBox="1"/>
          <p:nvPr/>
        </p:nvSpPr>
        <p:spPr>
          <a:xfrm>
            <a:off x="1017827" y="2993947"/>
            <a:ext cx="40662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b="1" dirty="0">
                <a:solidFill>
                  <a:srgbClr val="222222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)</a:t>
            </a:r>
            <a:r>
              <a:rPr lang="ja-JP" altLang="en-US" sz="800" b="1">
                <a:solidFill>
                  <a:srgbClr val="222222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　</a:t>
            </a:r>
            <a:endParaRPr lang="en-US" altLang="ja-JP" sz="800" b="1" dirty="0">
              <a:solidFill>
                <a:srgbClr val="222222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DA06A71-5CE1-84E1-2BC5-B7BD3F8041A9}"/>
              </a:ext>
            </a:extLst>
          </p:cNvPr>
          <p:cNvSpPr txBox="1"/>
          <p:nvPr/>
        </p:nvSpPr>
        <p:spPr>
          <a:xfrm>
            <a:off x="3429000" y="2993947"/>
            <a:ext cx="40662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b="1" dirty="0">
                <a:solidFill>
                  <a:srgbClr val="222222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B)</a:t>
            </a:r>
            <a:r>
              <a:rPr lang="ja-JP" altLang="en-US" sz="800" b="1">
                <a:solidFill>
                  <a:srgbClr val="222222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　</a:t>
            </a:r>
            <a:endParaRPr lang="en-US" altLang="ja-JP" sz="800" b="1" dirty="0">
              <a:solidFill>
                <a:srgbClr val="222222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71546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2CC10724-C9DF-E949-1090-9A4A5F0F40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0338338"/>
              </p:ext>
            </p:extLst>
          </p:nvPr>
        </p:nvGraphicFramePr>
        <p:xfrm>
          <a:off x="2194918" y="3889475"/>
          <a:ext cx="2367557" cy="16686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828243" imgH="2698634" progId="Prism8.Document">
                  <p:embed/>
                </p:oleObj>
              </mc:Choice>
              <mc:Fallback>
                <p:oleObj name="Prism 8" r:id="rId3" imgW="3828243" imgH="2698634" progId="Prism8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2CC10724-C9DF-E949-1090-9A4A5F0F40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94918" y="3889475"/>
                        <a:ext cx="2367557" cy="16686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A044660-32DE-9587-EC9C-D8899D6B5D26}"/>
              </a:ext>
            </a:extLst>
          </p:cNvPr>
          <p:cNvSpPr txBox="1"/>
          <p:nvPr/>
        </p:nvSpPr>
        <p:spPr>
          <a:xfrm>
            <a:off x="2075545" y="5601189"/>
            <a:ext cx="2821724" cy="7150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506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plemental Data S3. </a:t>
            </a:r>
            <a:r>
              <a:rPr lang="en-US" altLang="ja-JP" sz="506" b="1" dirty="0">
                <a:latin typeface="Arial" panose="020B0604020202020204" pitchFamily="34" charset="0"/>
                <a:cs typeface="Arial" panose="020B0604020202020204" pitchFamily="34" charset="0"/>
              </a:rPr>
              <a:t>Concordance between programmed death-ligand 1 expression in tumor biopsy and circulating tumor cells</a:t>
            </a:r>
          </a:p>
          <a:p>
            <a:endParaRPr lang="en-US" altLang="ja-JP" sz="506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lang="en-US" altLang="ja-JP" sz="506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o calculate %tumor proportion scores (%TPS), PD-L1 expression levels in lung tumor tissues were routinely evaluated by using the FDA-approved </a:t>
            </a:r>
            <a:r>
              <a:rPr lang="en-US" altLang="ja-JP" sz="506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ako</a:t>
            </a:r>
            <a:r>
              <a:rPr lang="en-US" altLang="ja-JP" sz="506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D-L1 immunohistochemistry 22C3 </a:t>
            </a:r>
            <a:r>
              <a:rPr lang="en-US" altLang="ja-JP" sz="506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harmDx</a:t>
            </a:r>
            <a:r>
              <a:rPr lang="en-US" altLang="ja-JP" sz="506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ssay. The x-axis reveals the %TPS of individual tumor biopsy samples, and the y-axis shows the corresponding %PD-L1</a:t>
            </a:r>
            <a:r>
              <a:rPr lang="en-US" altLang="ja-JP" sz="506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+)</a:t>
            </a:r>
            <a:r>
              <a:rPr lang="en-US" altLang="ja-JP" sz="506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TC among all CTC counts. Rs and </a:t>
            </a:r>
            <a:r>
              <a:rPr lang="en-US" altLang="ja-JP" sz="506" i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</a:t>
            </a:r>
            <a:r>
              <a:rPr lang="en-US" altLang="ja-JP" sz="506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values were calculated using the Spearman correlation coefficient.</a:t>
            </a:r>
            <a:endParaRPr lang="ja-JP" altLang="en-US" sz="50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F1EB423-58CF-CCB4-EAF1-2BE6554FC50F}"/>
              </a:ext>
            </a:extLst>
          </p:cNvPr>
          <p:cNvSpPr txBox="1"/>
          <p:nvPr/>
        </p:nvSpPr>
        <p:spPr>
          <a:xfrm>
            <a:off x="3624561" y="4762133"/>
            <a:ext cx="575964" cy="2480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506" dirty="0">
                <a:latin typeface="Arial" panose="020B0604020202020204" pitchFamily="34" charset="0"/>
                <a:cs typeface="Arial" panose="020B0604020202020204" pitchFamily="34" charset="0"/>
              </a:rPr>
              <a:t> Rs = -0.003</a:t>
            </a:r>
          </a:p>
          <a:p>
            <a:r>
              <a:rPr lang="en-US" altLang="ja-JP" sz="506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506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506" dirty="0">
                <a:latin typeface="Arial" panose="020B0604020202020204" pitchFamily="34" charset="0"/>
                <a:cs typeface="Arial" panose="020B0604020202020204" pitchFamily="34" charset="0"/>
              </a:rPr>
              <a:t> = 0.982</a:t>
            </a:r>
            <a:endParaRPr lang="ja-JP" altLang="en-US" sz="50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34770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8DCDB66-DFAD-263A-A2FB-31B0D85C02D9}"/>
              </a:ext>
            </a:extLst>
          </p:cNvPr>
          <p:cNvSpPr txBox="1"/>
          <p:nvPr/>
        </p:nvSpPr>
        <p:spPr>
          <a:xfrm>
            <a:off x="1510509" y="5901209"/>
            <a:ext cx="3650136" cy="5593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506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plemental Data S4. Association of programmed death-ligand 1 (PD-L1) positive ratio of circulating tumor cells (CTCs) with PFS in patients treated with regimens, including immune checkpoint inhibitors (ICIs).</a:t>
            </a:r>
          </a:p>
          <a:p>
            <a:endParaRPr lang="en-US" altLang="ja-JP" sz="506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High PD-L1 expression ratio of CTCs (≥50 %) was not associated with prolonged PFS in patients treated with regimens including ICIs. </a:t>
            </a:r>
            <a:r>
              <a:rPr lang="en-US" altLang="ja-JP" sz="506" i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</a:t>
            </a:r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-values were calculated using the log-rank test. Hazard ratios (HRs) were calculated using the Cox proportional hazards model.</a:t>
            </a:r>
            <a:endParaRPr lang="en-US" altLang="ja-JP" sz="50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E68751EE-B0EE-7BD1-3E17-C7E2EFAEAF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0787837"/>
              </p:ext>
            </p:extLst>
          </p:nvPr>
        </p:nvGraphicFramePr>
        <p:xfrm>
          <a:off x="2591690" y="3703601"/>
          <a:ext cx="2398525" cy="17744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855613" imgH="2849539" progId="Prism8.Document">
                  <p:embed/>
                </p:oleObj>
              </mc:Choice>
              <mc:Fallback>
                <p:oleObj name="Prism 8" r:id="rId3" imgW="3855613" imgH="2849539" progId="Prism8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E68751EE-B0EE-7BD1-3E17-C7E2EFAEAF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91690" y="3703601"/>
                        <a:ext cx="2398525" cy="17744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5639D1C-6484-89C3-EB33-F9BDED51342E}"/>
              </a:ext>
            </a:extLst>
          </p:cNvPr>
          <p:cNvSpPr txBox="1"/>
          <p:nvPr/>
        </p:nvSpPr>
        <p:spPr>
          <a:xfrm>
            <a:off x="3034453" y="4857248"/>
            <a:ext cx="824773" cy="2308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4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450" dirty="0">
                <a:latin typeface="Arial" panose="020B0604020202020204" pitchFamily="34" charset="0"/>
                <a:cs typeface="Arial" panose="020B0604020202020204" pitchFamily="34" charset="0"/>
              </a:rPr>
              <a:t> = 0.842</a:t>
            </a:r>
          </a:p>
          <a:p>
            <a:r>
              <a:rPr lang="en-US" altLang="ja-JP" sz="450" dirty="0">
                <a:latin typeface="Arial" panose="020B0604020202020204" pitchFamily="34" charset="0"/>
                <a:cs typeface="Arial" panose="020B0604020202020204" pitchFamily="34" charset="0"/>
              </a:rPr>
              <a:t>HR 1.075 (0.524-2.207)</a:t>
            </a:r>
            <a:endParaRPr lang="ja-JP" altLang="en-US" sz="4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B2EADA3-3C88-630A-C37A-F17DCE988892}"/>
              </a:ext>
            </a:extLst>
          </p:cNvPr>
          <p:cNvSpPr txBox="1"/>
          <p:nvPr/>
        </p:nvSpPr>
        <p:spPr>
          <a:xfrm>
            <a:off x="2877214" y="5289864"/>
            <a:ext cx="56962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DAE590A-43AF-5E76-9BD2-1F055E5A49B6}"/>
              </a:ext>
            </a:extLst>
          </p:cNvPr>
          <p:cNvSpPr txBox="1"/>
          <p:nvPr/>
        </p:nvSpPr>
        <p:spPr>
          <a:xfrm>
            <a:off x="2881933" y="5385630"/>
            <a:ext cx="2122458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24          15          11           7            4            2            0</a:t>
            </a:r>
          </a:p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25          16          11           7            6            6            3 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B23DE91-EB44-91E6-8660-9B281467C885}"/>
              </a:ext>
            </a:extLst>
          </p:cNvPr>
          <p:cNvSpPr txBox="1"/>
          <p:nvPr/>
        </p:nvSpPr>
        <p:spPr>
          <a:xfrm>
            <a:off x="1623235" y="5385630"/>
            <a:ext cx="1298179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  <a:r>
              <a:rPr lang="en-US" altLang="ja-JP" sz="563" baseline="300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+) </a:t>
            </a:r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CTCs / CTCs 0%–49%</a:t>
            </a:r>
          </a:p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  <a:r>
              <a:rPr lang="en-US" altLang="ja-JP" sz="563" baseline="300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+) </a:t>
            </a:r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CTCs / CTCs 50%–100%</a:t>
            </a:r>
          </a:p>
        </p:txBody>
      </p:sp>
    </p:spTree>
    <p:extLst>
      <p:ext uri="{BB962C8B-B14F-4D97-AF65-F5344CB8AC3E}">
        <p14:creationId xmlns:p14="http://schemas.microsoft.com/office/powerpoint/2010/main" val="39846547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6062871E-1316-2DE9-7141-853F5444D4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524235"/>
              </p:ext>
            </p:extLst>
          </p:nvPr>
        </p:nvGraphicFramePr>
        <p:xfrm>
          <a:off x="2508014" y="4003655"/>
          <a:ext cx="1760934" cy="1692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463785" imgH="3357356" progId="Prism8.Document">
                  <p:embed/>
                </p:oleObj>
              </mc:Choice>
              <mc:Fallback>
                <p:oleObj name="Prism 8" r:id="rId3" imgW="3463785" imgH="3357356" progId="Prism8.Document">
                  <p:embed/>
                  <p:pic>
                    <p:nvPicPr>
                      <p:cNvPr id="8" name="オブジェクト 7">
                        <a:extLst>
                          <a:ext uri="{FF2B5EF4-FFF2-40B4-BE49-F238E27FC236}">
                            <a16:creationId xmlns:a16="http://schemas.microsoft.com/office/drawing/2014/main" id="{6062871E-1316-2DE9-7141-853F5444D4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08014" y="4003655"/>
                        <a:ext cx="1760934" cy="1692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858BFEE-22F3-CC6F-58CF-B44EEEEF08A8}"/>
              </a:ext>
            </a:extLst>
          </p:cNvPr>
          <p:cNvSpPr txBox="1"/>
          <p:nvPr/>
        </p:nvSpPr>
        <p:spPr>
          <a:xfrm>
            <a:off x="1776735" y="5544562"/>
            <a:ext cx="3636243" cy="4037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506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plemental Data S5. Dynamic monitoring of circulating tumor cell counts until progressive disease</a:t>
            </a:r>
          </a:p>
          <a:p>
            <a:endParaRPr lang="en-US" altLang="ja-JP" sz="506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rogrammed death-ligand 1 (PD-L1)</a:t>
            </a:r>
            <a:r>
              <a:rPr lang="en-US" altLang="ja-JP" sz="506" baseline="300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+) </a:t>
            </a:r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CTC counts before and after disease progression. </a:t>
            </a:r>
            <a:r>
              <a:rPr lang="en-US" altLang="ja-JP" sz="506" i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</a:t>
            </a:r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-values were calculated using the Wilcoxon signed-rank test.</a:t>
            </a:r>
            <a:endParaRPr lang="en-US" altLang="ja-JP" sz="506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14297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" name="オブジェクト 55">
            <a:extLst>
              <a:ext uri="{FF2B5EF4-FFF2-40B4-BE49-F238E27FC236}">
                <a16:creationId xmlns:a16="http://schemas.microsoft.com/office/drawing/2014/main" id="{41280CC5-BBEF-A0C7-AA36-56ECAD7B67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5394976"/>
              </p:ext>
            </p:extLst>
          </p:nvPr>
        </p:nvGraphicFramePr>
        <p:xfrm>
          <a:off x="2357902" y="3535907"/>
          <a:ext cx="2421327" cy="1796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855613" imgH="2858903" progId="Prism8.Document">
                  <p:embed/>
                </p:oleObj>
              </mc:Choice>
              <mc:Fallback>
                <p:oleObj name="Prism 8" r:id="rId3" imgW="3855613" imgH="2858903" progId="Prism8.Document">
                  <p:embed/>
                  <p:pic>
                    <p:nvPicPr>
                      <p:cNvPr id="56" name="オブジェクト 55">
                        <a:extLst>
                          <a:ext uri="{FF2B5EF4-FFF2-40B4-BE49-F238E27FC236}">
                            <a16:creationId xmlns:a16="http://schemas.microsoft.com/office/drawing/2014/main" id="{41280CC5-BBEF-A0C7-AA36-56ECAD7B67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57902" y="3535907"/>
                        <a:ext cx="2421327" cy="1796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7CAE1D2-7E06-8206-E411-9665A3823E9D}"/>
              </a:ext>
            </a:extLst>
          </p:cNvPr>
          <p:cNvSpPr txBox="1"/>
          <p:nvPr/>
        </p:nvSpPr>
        <p:spPr>
          <a:xfrm>
            <a:off x="2822250" y="4724453"/>
            <a:ext cx="824773" cy="2308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45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4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40</a:t>
            </a:r>
          </a:p>
          <a:p>
            <a:r>
              <a:rPr lang="en-US" altLang="ja-JP" sz="4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 1.910 (1.014-3.595)</a:t>
            </a:r>
            <a:endParaRPr lang="ja-JP" altLang="en-US" sz="4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8E0A7785-1C05-3D9A-1F01-43BC1E9F6698}"/>
              </a:ext>
            </a:extLst>
          </p:cNvPr>
          <p:cNvSpPr txBox="1"/>
          <p:nvPr/>
        </p:nvSpPr>
        <p:spPr>
          <a:xfrm>
            <a:off x="2665389" y="5160197"/>
            <a:ext cx="56962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F48CB09-CBEB-F962-1232-DF43B8B1992F}"/>
              </a:ext>
            </a:extLst>
          </p:cNvPr>
          <p:cNvSpPr txBox="1"/>
          <p:nvPr/>
        </p:nvSpPr>
        <p:spPr>
          <a:xfrm>
            <a:off x="2670107" y="5255962"/>
            <a:ext cx="1991653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21          12           4            2            3            1           1</a:t>
            </a:r>
          </a:p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29          22          13           9            8            4           3 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6C6D6897-AC62-DB4A-833B-D09AB3181C58}"/>
              </a:ext>
            </a:extLst>
          </p:cNvPr>
          <p:cNvSpPr txBox="1"/>
          <p:nvPr/>
        </p:nvSpPr>
        <p:spPr>
          <a:xfrm>
            <a:off x="1926269" y="5254767"/>
            <a:ext cx="839275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ΔPD-L1</a:t>
            </a:r>
            <a:r>
              <a:rPr lang="en-US" altLang="ja-JP" sz="563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(+) </a:t>
            </a:r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CTC </a:t>
            </a:r>
            <a:r>
              <a:rPr lang="en-US" altLang="ja-JP" sz="563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ΔPD-L1</a:t>
            </a:r>
            <a:r>
              <a:rPr lang="en-US" altLang="ja-JP" sz="563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(+) </a:t>
            </a:r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CTC </a:t>
            </a:r>
            <a:r>
              <a:rPr lang="en-US" altLang="ja-JP" sz="563" dirty="0">
                <a:latin typeface="Arial" panose="020B0604020202020204" pitchFamily="34" charset="0"/>
                <a:cs typeface="Arial" panose="020B0604020202020204" pitchFamily="34" charset="0"/>
              </a:rPr>
              <a:t>≤ </a:t>
            </a:r>
            <a:r>
              <a:rPr lang="en-US" altLang="ja-JP" sz="563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849005A-A869-4512-61EE-CFDA26890A30}"/>
              </a:ext>
            </a:extLst>
          </p:cNvPr>
          <p:cNvSpPr txBox="1"/>
          <p:nvPr/>
        </p:nvSpPr>
        <p:spPr>
          <a:xfrm>
            <a:off x="1428205" y="5794898"/>
            <a:ext cx="4136520" cy="4815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506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plemental </a:t>
            </a:r>
            <a:r>
              <a:rPr lang="en-US" altLang="ja-JP" sz="506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ata S6</a:t>
            </a:r>
            <a:r>
              <a:rPr lang="en-US" altLang="ja-JP" sz="506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. Association of changes in circulating tumor cell measurements with progression-free survival</a:t>
            </a:r>
          </a:p>
          <a:p>
            <a:endParaRPr lang="en-US" altLang="ja-JP" sz="506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  <a:p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Changes in CTC and programmed death-ligand 1 (PD-L1)</a:t>
            </a:r>
            <a:r>
              <a:rPr lang="en-US" altLang="ja-JP" sz="506" baseline="300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+)</a:t>
            </a:r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CTC were determined for up to two cycles of treatment. Increase in PD-L1</a:t>
            </a:r>
            <a:r>
              <a:rPr lang="en-US" altLang="ja-JP" sz="506" baseline="300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(+) </a:t>
            </a:r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CTC count (versus equal/down) between pre-treatment and two cycles of post-treatment was associated with poor PFS. </a:t>
            </a:r>
            <a:r>
              <a:rPr lang="en-US" altLang="ja-JP" sz="506" i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</a:t>
            </a:r>
            <a:r>
              <a:rPr lang="en-US" altLang="ja-JP" sz="506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-values were calculated using the log-rank test. Hazard ratio (HR) was calculated using the Cox proportional hazards model</a:t>
            </a:r>
            <a:r>
              <a:rPr lang="en-US" altLang="ja-JP" sz="506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7584531-60F1-45D9-1FC1-C26B5AE36E8F}"/>
              </a:ext>
            </a:extLst>
          </p:cNvPr>
          <p:cNvSpPr txBox="1"/>
          <p:nvPr/>
        </p:nvSpPr>
        <p:spPr>
          <a:xfrm>
            <a:off x="4370310" y="3581319"/>
            <a:ext cx="148532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63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</a:p>
          <a:p>
            <a:r>
              <a:rPr lang="en-US" altLang="ja-JP" sz="563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≤</a:t>
            </a:r>
          </a:p>
        </p:txBody>
      </p:sp>
    </p:spTree>
    <p:extLst>
      <p:ext uri="{BB962C8B-B14F-4D97-AF65-F5344CB8AC3E}">
        <p14:creationId xmlns:p14="http://schemas.microsoft.com/office/powerpoint/2010/main" val="3022669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9285</TotalTime>
  <Words>782</Words>
  <Application>Microsoft Office PowerPoint</Application>
  <PresentationFormat>A4 Paper (210x297 mm)</PresentationFormat>
  <Paragraphs>112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Office 2013 - 2022 テーマ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十合 晋作</dc:creator>
  <cp:lastModifiedBy>MDPI</cp:lastModifiedBy>
  <cp:revision>218</cp:revision>
  <cp:lastPrinted>2024-12-18T05:27:34Z</cp:lastPrinted>
  <dcterms:created xsi:type="dcterms:W3CDTF">2022-04-30T00:59:20Z</dcterms:created>
  <dcterms:modified xsi:type="dcterms:W3CDTF">2025-10-01T04:07:51Z</dcterms:modified>
</cp:coreProperties>
</file>